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0" r:id="rId3"/>
    <p:sldId id="262" r:id="rId4"/>
    <p:sldId id="265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6" autoAdjust="0"/>
    <p:restoredTop sz="94660"/>
  </p:normalViewPr>
  <p:slideViewPr>
    <p:cSldViewPr snapToGrid="0">
      <p:cViewPr varScale="1">
        <p:scale>
          <a:sx n="97" d="100"/>
          <a:sy n="97" d="100"/>
        </p:scale>
        <p:origin x="78" y="3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9331B-5375-4169-8353-6F8D4107AAB4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8A633-59BC-406A-AE46-410BB0B537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841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9331B-5375-4169-8353-6F8D4107AAB4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8A633-59BC-406A-AE46-410BB0B537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507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9331B-5375-4169-8353-6F8D4107AAB4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8A633-59BC-406A-AE46-410BB0B537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568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9331B-5375-4169-8353-6F8D4107AAB4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8A633-59BC-406A-AE46-410BB0B537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9507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9331B-5375-4169-8353-6F8D4107AAB4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8A633-59BC-406A-AE46-410BB0B537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866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9331B-5375-4169-8353-6F8D4107AAB4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8A633-59BC-406A-AE46-410BB0B537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118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9331B-5375-4169-8353-6F8D4107AAB4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8A633-59BC-406A-AE46-410BB0B537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8854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9331B-5375-4169-8353-6F8D4107AAB4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8A633-59BC-406A-AE46-410BB0B537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232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9331B-5375-4169-8353-6F8D4107AAB4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8A633-59BC-406A-AE46-410BB0B537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277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9331B-5375-4169-8353-6F8D4107AAB4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8A633-59BC-406A-AE46-410BB0B537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3974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9331B-5375-4169-8353-6F8D4107AAB4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8A633-59BC-406A-AE46-410BB0B537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989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69331B-5375-4169-8353-6F8D4107AAB4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8A633-59BC-406A-AE46-410BB0B537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1698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5808" y="368808"/>
            <a:ext cx="5522976" cy="55229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322576" y="5891784"/>
            <a:ext cx="8444941" cy="11233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1: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he detection of false positives via within group analysis of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dLC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, OC and TNBC data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lustrated are the </a:t>
            </a:r>
            <a:r>
              <a:rPr lang="en-US" altLang="en-US" sz="1100" u="sng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mber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false positives </a:t>
            </a:r>
            <a:r>
              <a:rPr lang="en-US" alt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dentifi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d from the RLE (pink), TMM (green), UQ (blue)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UQ-pgQ2 (purple) normalization using </a:t>
            </a:r>
            <a:r>
              <a:rPr lang="en-US" alt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act test</a:t>
            </a:r>
            <a:r>
              <a:rPr kumimoji="0" lang="en-US" altLang="en-US" sz="1100" b="0" i="0" u="sng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QL F-test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r Wald test for sample sizes of 5, 10, 15, 20, 25, 30, 35 and 40.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plots are based on 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LC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ata (a</a:t>
            </a:r>
            <a:r>
              <a:rPr lang="en-US" altLang="en-US" sz="1100" u="sng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kumimoji="0" lang="en-US" altLang="en-US" sz="1100" b="0" i="0" u="sng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OC data (</a:t>
            </a:r>
            <a:r>
              <a:rPr kumimoji="0" lang="en-US" altLang="en-US" sz="1100" b="0" i="0" u="sng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-f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TNBC data (</a:t>
            </a:r>
            <a:r>
              <a:rPr kumimoji="0" lang="en-US" altLang="en-US" sz="1100" b="0" i="0" u="sng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-</a:t>
            </a:r>
            <a:r>
              <a:rPr kumimoji="0" lang="en-US" altLang="en-US" sz="1100" b="0" i="0" u="sng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alt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US" altLang="en-US" dirty="0">
              <a:latin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86531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2384" y="213360"/>
            <a:ext cx="5321808" cy="532180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889504" y="5650992"/>
            <a:ext cx="8808822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2: The number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of false positives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dentified via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within group analysis of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C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amples with different read depths. 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llustrated ar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number of false positive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dentified from th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LE, TMM, UQ and UQ-pgQ2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ormalization with the exact test, QL F-test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al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est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or sample size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f 5, 10, 15, 20, 25, 30, 35 and 40. The plots are based on a read depth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rom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9 to 157 million (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-c),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rom 12.8 to 104 million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d-f),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from 9.6 to 78.6 million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g-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88952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5808" y="368808"/>
            <a:ext cx="5166360" cy="516636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189153" y="5662594"/>
            <a:ext cx="8783174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3: The number of false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ositives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dentified from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n exact test and a Wald test via within group analysis of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C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amples.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llustrated are the number of false positives identified</a:t>
            </a:r>
            <a:r>
              <a:rPr kumimoji="0" lang="en-US" altLang="en-US" sz="11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rom</a:t>
            </a:r>
            <a:r>
              <a:rPr lang="en-US" alt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altLang="en-US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LE, TMM and UQ-pgQ2 normalization methods,</a:t>
            </a:r>
            <a:r>
              <a:rPr kumimoji="0" lang="en-US" altLang="en-US" sz="11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sed on the read depths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rom 19 to 157 million</a:t>
            </a:r>
            <a:r>
              <a:rPr kumimoji="0" lang="en-US" altLang="en-US" sz="11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a-c), 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rom 12.8 to 104 million</a:t>
            </a:r>
            <a:r>
              <a:rPr kumimoji="0" lang="en-US" altLang="en-US" sz="11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d-f) 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from 9.6 to 78.6 million(g-</a:t>
            </a:r>
            <a:r>
              <a:rPr kumimoji="0" lang="en-US" alt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45724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699446" y="5466588"/>
            <a:ext cx="8167621" cy="1277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4: The number of False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ositives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dentifie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rom simulated data with variable read depths and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xed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ampl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zes.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llustrated ar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number of false positive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dentifi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rom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e RL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TMM, UQ and UQ-pgQ2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using th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xact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est,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QL F-test or Wal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est for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mple size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f 5, 10, 15, 20, 25, 30, 35 an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0. 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lots are based on 122 simulated data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ith the mean read depth of 30 million and SD of 3 (a-</a:t>
            </a:r>
            <a:r>
              <a:rPr kumimoji="0" lang="en-US" altLang="en-US" sz="1100" b="0" i="0" u="sng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or 5</a:t>
            </a:r>
            <a:r>
              <a:rPr kumimoji="0" lang="en-US" altLang="en-US" sz="1100" b="0" i="0" u="sng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llion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d</a:t>
            </a:r>
            <a:r>
              <a:rPr lang="en-US" altLang="en-US" sz="1100" u="sng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kumimoji="0" lang="en-US" altLang="en-US" sz="1100" b="0" i="0" u="sng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; a mean read depth of 40 million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SD of 3 (</a:t>
            </a:r>
            <a:r>
              <a:rPr kumimoji="0" lang="en-US" altLang="en-US" sz="1100" b="0" i="0" u="sng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-</a:t>
            </a:r>
            <a:r>
              <a:rPr kumimoji="0" lang="en-US" altLang="en-US" sz="1100" b="0" i="0" u="sng" strike="noStrike" cap="none" normalizeH="0" baseline="0" dirty="0" err="1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or 5 </a:t>
            </a:r>
            <a:r>
              <a:rPr kumimoji="0" lang="en-US" altLang="en-US" sz="1100" b="0" i="0" u="sng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llion 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kumimoji="0" lang="en-US" altLang="en-US" sz="1100" b="0" i="0" u="sng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j-l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; a mean read depth of 50 million reads and SD of 3 (</a:t>
            </a:r>
            <a:r>
              <a:rPr kumimoji="0" lang="en-US" altLang="en-US" sz="1100" b="0" i="0" u="sng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-o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 5</a:t>
            </a:r>
            <a:r>
              <a:rPr kumimoji="0" lang="en-US" altLang="en-US" sz="1100" b="0" i="0" u="sng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llion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kumimoji="0" lang="en-US" altLang="en-US" sz="1100" b="0" i="0" u="sng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-r</a:t>
            </a: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</a:t>
            </a:r>
            <a:endParaRPr lang="en-US" altLang="en-US" dirty="0">
              <a:latin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3292" y="560832"/>
            <a:ext cx="6120384" cy="49057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3858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</TotalTime>
  <Words>411</Words>
  <Application>Microsoft Office PowerPoint</Application>
  <PresentationFormat>Widescreen</PresentationFormat>
  <Paragraphs>1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aohong Li</dc:creator>
  <cp:lastModifiedBy>Xiaohong Li</cp:lastModifiedBy>
  <cp:revision>22</cp:revision>
  <dcterms:created xsi:type="dcterms:W3CDTF">2019-12-09T17:49:24Z</dcterms:created>
  <dcterms:modified xsi:type="dcterms:W3CDTF">2020-01-10T21:58:05Z</dcterms:modified>
</cp:coreProperties>
</file>